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108"/>
    <p:restoredTop sz="94679"/>
  </p:normalViewPr>
  <p:slideViewPr>
    <p:cSldViewPr snapToGrid="0">
      <p:cViewPr varScale="1">
        <p:scale>
          <a:sx n="104" d="100"/>
          <a:sy n="104" d="100"/>
        </p:scale>
        <p:origin x="808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725C91-0C84-0C45-BF88-93F84B76B18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782B8C3-7062-F67F-3240-C44E3D6559C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7FF1AB-DD17-7BFC-D991-B3EB4A9A20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71F1E-48C9-434F-B967-6443F03EE980}" type="datetimeFigureOut">
              <a:rPr lang="en-US" smtClean="0"/>
              <a:t>2/13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8B1F4D-9E89-6F78-4D32-CC778AFF1B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A46905-29BC-1C58-156D-9D30BEAA31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6C69E-6036-1941-B03A-41FB682DA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78831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6B82AB-EDFF-48EF-49FB-D2F5334CAF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CD2CD0D-95E1-E17A-9C3E-0329805FE21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312045-7314-6478-C614-B1ADEFAAB2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71F1E-48C9-434F-B967-6443F03EE980}" type="datetimeFigureOut">
              <a:rPr lang="en-US" smtClean="0"/>
              <a:t>2/13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694D99-FC4A-3C2E-4755-149651463C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3D59C7-576A-55D3-0FEA-88795F42CB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6C69E-6036-1941-B03A-41FB682DA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07628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8B2ABD1-E373-4CE8-6B1B-21F28595AC2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80EB21B-F0EA-A5C9-9595-39F7058530F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A16F2A-9628-B32E-B177-ADEFFB2341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71F1E-48C9-434F-B967-6443F03EE980}" type="datetimeFigureOut">
              <a:rPr lang="en-US" smtClean="0"/>
              <a:t>2/13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B971A0-D467-7743-D91A-E7EC51F470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FA50D8-D4F4-F7A9-6DDC-D7B8000E34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6C69E-6036-1941-B03A-41FB682DA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07593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2AD56F-852C-9BFA-4F38-7590B9BB40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2D12A7-DCEE-BFB2-20B1-B0C4F94A814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74273E-7BF4-0D8C-B6F6-AD5C18AF40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71F1E-48C9-434F-B967-6443F03EE980}" type="datetimeFigureOut">
              <a:rPr lang="en-US" smtClean="0"/>
              <a:t>2/13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85AB5D-CB7F-91A9-ABD0-C074D421FB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BFF3CA-A44B-4088-BEAE-756D5CC0A1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6C69E-6036-1941-B03A-41FB682DA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33942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3C4EA4-D32F-0987-66A2-0BCE4AB0EC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841CC0F-5506-D116-2C66-8BB2F05E2B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915EBF-933D-7520-9DB8-8B71B68D7C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71F1E-48C9-434F-B967-6443F03EE980}" type="datetimeFigureOut">
              <a:rPr lang="en-US" smtClean="0"/>
              <a:t>2/13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612D58-2712-DD5F-2589-86E5AEFBBF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D65801-8178-CA44-5BE8-4DCE0E2A60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6C69E-6036-1941-B03A-41FB682DA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55255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B1342C-D327-CA8E-DE3C-9A3942B803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A9B623-B496-B635-09B7-4B4DBC78FC9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869C01C-0D62-3309-D9C1-E57C0352B8E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BD7CB4D-0BC0-6074-E32C-4AAC6AA800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71F1E-48C9-434F-B967-6443F03EE980}" type="datetimeFigureOut">
              <a:rPr lang="en-US" smtClean="0"/>
              <a:t>2/13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4FA99F0-2100-CAE1-34C1-F46AEC8143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B9A0B9E-A4AB-3347-C090-DA878E65A3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6C69E-6036-1941-B03A-41FB682DA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72349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84F80B-8EA7-AE1E-732A-E76B624EBB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EF27D3F-535C-9149-BCE6-1D024E881D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B62F531-A27B-5EBF-D5ED-39321EF3895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21A2719-0BD4-3250-7810-19578245A8B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A2FA592-102B-C4AD-AFAD-0D916D7A975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4550DDD-CD9C-C6FD-4325-49988C1B74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71F1E-48C9-434F-B967-6443F03EE980}" type="datetimeFigureOut">
              <a:rPr lang="en-US" smtClean="0"/>
              <a:t>2/13/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2C042EC-A167-FD2F-DC36-41D2BBA1B8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874E9D3-548C-6E1F-96A0-1DE0BF8C45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6C69E-6036-1941-B03A-41FB682DA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99595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349D02-AA1C-F484-D0FF-12BFDB2BA0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4D4EA79-6F73-0E28-F375-0393D0464F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71F1E-48C9-434F-B967-6443F03EE980}" type="datetimeFigureOut">
              <a:rPr lang="en-US" smtClean="0"/>
              <a:t>2/13/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D7C6F03-0C59-A493-1039-D008001CE6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0C290EB-06CD-F3E8-F252-70284BABE0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6C69E-6036-1941-B03A-41FB682DA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88350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6AF2586-5F29-85DB-B650-8CCD5FE319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71F1E-48C9-434F-B967-6443F03EE980}" type="datetimeFigureOut">
              <a:rPr lang="en-US" smtClean="0"/>
              <a:t>2/13/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D467ECA-3E04-D961-7846-1B3FCA8476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E8B7337-F6C1-019E-BF72-F598EEDD10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6C69E-6036-1941-B03A-41FB682DA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48549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C71BC4-791B-68F1-001D-1FFC2657CA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2B42BCC-FA7F-1EE7-071E-9B32AC2C574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3AF086B-A711-A3A1-26F5-3E8E3F8B67E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8246FA8-7F4A-DF33-3A9D-7B8F5302A1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71F1E-48C9-434F-B967-6443F03EE980}" type="datetimeFigureOut">
              <a:rPr lang="en-US" smtClean="0"/>
              <a:t>2/13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0E3E8B3-1081-4E8D-6C93-8C147F4549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86622DD-71F4-5F2C-9D4E-7381E4BAB4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6C69E-6036-1941-B03A-41FB682DA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27635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973C55-3532-BE1E-90F4-AF5FF5EAEA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24E420F-194B-02DC-8997-08967AC51C0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0605691-A9D5-8CBB-3B54-2440AEA1588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1BF0036-54BB-78D7-7708-DD42F6B47E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71F1E-48C9-434F-B967-6443F03EE980}" type="datetimeFigureOut">
              <a:rPr lang="en-US" smtClean="0"/>
              <a:t>2/13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097CA8E-47CA-4E68-1975-2D5DA6EC48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634DB26-9D45-8F20-BE8A-A5A631065B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6C69E-6036-1941-B03A-41FB682DA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78765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0016E2C-A7A0-EA29-7EDD-5B7DC83947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6E65778-A86C-EBFB-4606-4A9F7F807B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A39410-C92B-13D3-6DA9-7F041649DF8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2671F1E-48C9-434F-B967-6443F03EE980}" type="datetimeFigureOut">
              <a:rPr lang="en-US" smtClean="0"/>
              <a:t>2/13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1462D8-CFDC-B250-4764-243D4C8A3CD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2104AE-25DF-2BCA-23BD-2B423D6CFB6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936C69E-6036-1941-B03A-41FB682DA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77640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5C3C0C57-8088-4C9E-C4D4-01968FBC3DB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73852255"/>
              </p:ext>
            </p:extLst>
          </p:nvPr>
        </p:nvGraphicFramePr>
        <p:xfrm>
          <a:off x="331118" y="168485"/>
          <a:ext cx="6949440" cy="632534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89888">
                  <a:extLst>
                    <a:ext uri="{9D8B030D-6E8A-4147-A177-3AD203B41FA5}">
                      <a16:colId xmlns:a16="http://schemas.microsoft.com/office/drawing/2014/main" val="2579179431"/>
                    </a:ext>
                  </a:extLst>
                </a:gridCol>
                <a:gridCol w="1389888">
                  <a:extLst>
                    <a:ext uri="{9D8B030D-6E8A-4147-A177-3AD203B41FA5}">
                      <a16:colId xmlns:a16="http://schemas.microsoft.com/office/drawing/2014/main" val="1226093156"/>
                    </a:ext>
                  </a:extLst>
                </a:gridCol>
                <a:gridCol w="1389888">
                  <a:extLst>
                    <a:ext uri="{9D8B030D-6E8A-4147-A177-3AD203B41FA5}">
                      <a16:colId xmlns:a16="http://schemas.microsoft.com/office/drawing/2014/main" val="692217408"/>
                    </a:ext>
                  </a:extLst>
                </a:gridCol>
                <a:gridCol w="1389888">
                  <a:extLst>
                    <a:ext uri="{9D8B030D-6E8A-4147-A177-3AD203B41FA5}">
                      <a16:colId xmlns:a16="http://schemas.microsoft.com/office/drawing/2014/main" val="1767072746"/>
                    </a:ext>
                  </a:extLst>
                </a:gridCol>
                <a:gridCol w="1389888">
                  <a:extLst>
                    <a:ext uri="{9D8B030D-6E8A-4147-A177-3AD203B41FA5}">
                      <a16:colId xmlns:a16="http://schemas.microsoft.com/office/drawing/2014/main" val="435654608"/>
                    </a:ext>
                  </a:extLst>
                </a:gridCol>
              </a:tblGrid>
              <a:tr h="486565">
                <a:tc gridSpan="5">
                  <a:txBody>
                    <a:bodyPr/>
                    <a:lstStyle/>
                    <a:p>
                      <a:pPr algn="ctr"/>
                      <a:r>
                        <a:rPr lang="en-US" dirty="0"/>
                        <a:t>Myelin Water Fraction</a:t>
                      </a: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13774031"/>
                  </a:ext>
                </a:extLst>
              </a:tr>
              <a:tr h="486565"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Without Gd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With Gd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% Chang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p-</a:t>
                      </a:r>
                      <a:r>
                        <a:rPr lang="en-US" dirty="0" err="1"/>
                        <a:t>val</a:t>
                      </a:r>
                      <a:endParaRPr lang="en-US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780176176"/>
                  </a:ext>
                </a:extLst>
              </a:tr>
              <a:tr h="486565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SC 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0.35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0.36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1.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0.077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204747383"/>
                  </a:ext>
                </a:extLst>
              </a:tr>
              <a:tr h="486565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SC 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0.37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0.41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9.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&lt; 0.0001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533095409"/>
                  </a:ext>
                </a:extLst>
              </a:tr>
              <a:tr h="486565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SC 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0.38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0.37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-4.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0.0001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650856931"/>
                  </a:ext>
                </a:extLst>
              </a:tr>
              <a:tr h="486565">
                <a:tc gridSpan="5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8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rPr>
                        <a:t>Myelin Water T</a:t>
                      </a:r>
                      <a:r>
                        <a:rPr kumimoji="0" lang="en-US" sz="1800" b="1" i="0" u="none" strike="noStrike" kern="1200" cap="none" spc="0" normalizeH="0" baseline="-25000" noProof="0" dirty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rPr>
                        <a:t>2</a:t>
                      </a:r>
                      <a:r>
                        <a:rPr kumimoji="0" lang="en-US" sz="18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rPr>
                        <a:t> (ms)</a:t>
                      </a:r>
                    </a:p>
                  </a:txBody>
                  <a:tcPr anchor="ctr">
                    <a:solidFill>
                      <a:schemeClr val="tx2">
                        <a:lumMod val="50000"/>
                        <a:lumOff val="5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endParaRPr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02123375"/>
                  </a:ext>
                </a:extLst>
              </a:tr>
              <a:tr h="486565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SC 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8.9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9.2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3.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&lt; 0.0001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1831582"/>
                  </a:ext>
                </a:extLst>
              </a:tr>
              <a:tr h="486565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SC 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8.8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9.3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6.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&lt; 0.0001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231979100"/>
                  </a:ext>
                </a:extLst>
              </a:tr>
              <a:tr h="486565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SC 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8.6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9.7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1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&lt; 0.0001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62237948"/>
                  </a:ext>
                </a:extLst>
              </a:tr>
              <a:tr h="486565">
                <a:tc gridSpan="5">
                  <a:txBody>
                    <a:bodyPr/>
                    <a:lstStyle/>
                    <a:p>
                      <a:pPr algn="ctr"/>
                      <a:r>
                        <a:rPr lang="en-US" b="1" dirty="0">
                          <a:solidFill>
                            <a:schemeClr val="bg1"/>
                          </a:solidFill>
                          <a:latin typeface="+mn-lt"/>
                        </a:rPr>
                        <a:t>Other Water T</a:t>
                      </a:r>
                      <a:r>
                        <a:rPr lang="en-US" b="1" baseline="-25000" dirty="0">
                          <a:solidFill>
                            <a:schemeClr val="bg1"/>
                          </a:solidFill>
                          <a:latin typeface="+mn-lt"/>
                        </a:rPr>
                        <a:t>2 </a:t>
                      </a:r>
                      <a:r>
                        <a:rPr lang="en-US" b="1" baseline="0" dirty="0">
                          <a:solidFill>
                            <a:schemeClr val="bg1"/>
                          </a:solidFill>
                          <a:latin typeface="+mn-lt"/>
                        </a:rPr>
                        <a:t>(ms)</a:t>
                      </a:r>
                      <a:endParaRPr lang="en-US" b="1" baseline="-25000" dirty="0">
                        <a:solidFill>
                          <a:schemeClr val="bg1"/>
                        </a:solidFill>
                        <a:latin typeface="+mn-lt"/>
                      </a:endParaRPr>
                    </a:p>
                  </a:txBody>
                  <a:tcPr anchor="ctr">
                    <a:solidFill>
                      <a:schemeClr val="tx2">
                        <a:lumMod val="25000"/>
                        <a:lumOff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44894320"/>
                  </a:ext>
                </a:extLst>
              </a:tr>
              <a:tr h="486565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SC 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40.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29.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-2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&lt; 0.0001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0114761"/>
                  </a:ext>
                </a:extLst>
              </a:tr>
              <a:tr h="486565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SC 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41.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28.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-3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&lt; 0.0001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67307224"/>
                  </a:ext>
                </a:extLst>
              </a:tr>
              <a:tr h="486565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SC 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38.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28.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-2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&lt; 0.0001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035729224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8D7DF767-EF7E-517B-B404-A93902078C7E}"/>
              </a:ext>
            </a:extLst>
          </p:cNvPr>
          <p:cNvSpPr txBox="1"/>
          <p:nvPr/>
        </p:nvSpPr>
        <p:spPr>
          <a:xfrm>
            <a:off x="7670457" y="1954081"/>
            <a:ext cx="3969608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buNone/>
            </a:pPr>
            <a:r>
              <a:rPr lang="en-US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Table S1: 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MET</a:t>
            </a:r>
            <a:r>
              <a:rPr lang="en-US" sz="1800" kern="100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2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derived metrics for each spinal cord, with and without gadolinium. The p-values from </a:t>
            </a:r>
            <a:r>
              <a:rPr lang="en-US" sz="18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ranksum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comparisons and percent changes due to Gd are provided.</a:t>
            </a:r>
            <a:endParaRPr lang="en-US" sz="24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977525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117</Words>
  <Application>Microsoft Macintosh PowerPoint</Application>
  <PresentationFormat>Widescreen</PresentationFormat>
  <Paragraphs>5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lderson, Hannah E</dc:creator>
  <cp:lastModifiedBy>Alderson, Hannah E</cp:lastModifiedBy>
  <cp:revision>4</cp:revision>
  <dcterms:created xsi:type="dcterms:W3CDTF">2026-02-06T19:33:01Z</dcterms:created>
  <dcterms:modified xsi:type="dcterms:W3CDTF">2026-02-13T17:47:11Z</dcterms:modified>
</cp:coreProperties>
</file>